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7315200" cy="3657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0" y="685440"/>
            <a:ext cx="6858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300"/>
              </a:spcBef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fld id="{5B36ECD6-BFA5-4A9B-AE52-3F07163A3588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sldImg"/>
          </p:nvPr>
        </p:nvSpPr>
        <p:spPr>
          <a:xfrm>
            <a:off x="0" y="685800"/>
            <a:ext cx="6858000" cy="3429000"/>
          </a:xfrm>
          <a:prstGeom prst="rect">
            <a:avLst/>
          </a:prstGeom>
          <a:ln w="0">
            <a:noFill/>
          </a:ln>
        </p:spPr>
      </p:sp>
      <p:sp>
        <p:nvSpPr>
          <p:cNvPr id="7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300"/>
              </a:spcBef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fld id="{26C5F0DB-D395-4F80-BFEC-A5E27B9905A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DE22F7-410A-4409-9F67-8D9DD8497DB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658512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65040" y="2114280"/>
            <a:ext cx="658512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5CDAE1-BEF1-4A0E-96C6-C01904F210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73932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65040" y="211428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739320" y="211428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1D87BC-A20C-4E73-9B67-A9EF21AD2BD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591640" y="85356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817880" y="85356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65040" y="211428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591640" y="211428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817880" y="211428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1DC9FA-3DA1-40AC-AC0C-2CC53F6507B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65040" y="853560"/>
            <a:ext cx="6585120" cy="2413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50"/>
              </a:spcBef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0D88A2-0DEC-4136-918E-02F15F83DD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658512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D7EA3B-C648-4935-B766-7C4C271212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321336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739320" y="853560"/>
            <a:ext cx="321336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4CF465-46A4-4282-B4C5-B45312B192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18721A-451B-4941-9768-898BEE06AA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65040" y="145800"/>
            <a:ext cx="6585120" cy="2826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50"/>
              </a:spcBef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52F03D-4807-464C-BB57-4E1F4F1112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739320" y="853560"/>
            <a:ext cx="321336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65040" y="211428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40EAC3-9B7C-4CBD-9171-648819028F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321336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73932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739320" y="211428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087090-DAE0-433C-B15D-B85A71040C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73932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65040" y="2114280"/>
            <a:ext cx="658512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E3DEF8-9D8C-4E36-9B8D-EB2F7BD2CA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65040" y="853560"/>
            <a:ext cx="658512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 fontScale="85000"/>
          </a:bodyPr>
          <a:p>
            <a:pPr marL="203760" indent="-203760"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1" marL="442440" indent="-169560">
              <a:spcBef>
                <a:spcPts val="550"/>
              </a:spcBef>
              <a:buClr>
                <a:srgbClr val="000000"/>
              </a:buClr>
              <a:buFont typeface="Arial"/>
              <a:buChar char="–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2" marL="681120" indent="-136080"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3" marL="954000" indent="-136440">
              <a:spcBef>
                <a:spcPts val="550"/>
              </a:spcBef>
              <a:buClr>
                <a:srgbClr val="000000"/>
              </a:buClr>
              <a:buFont typeface="Arial"/>
              <a:buChar char="–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4" marL="1226160" indent="-13608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5" marL="1226160" indent="-13608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6" marL="1226160" indent="-13608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64680" y="3389400"/>
            <a:ext cx="1708200" cy="1951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  <a:defRPr b="0" lang="en-US" sz="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8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498760" y="3389400"/>
            <a:ext cx="2317680" cy="1951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241600" y="3389400"/>
            <a:ext cx="1708200" cy="1951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  <a:defRPr b="0" lang="en-US" sz="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fld id="{A0C7B8F0-6CA8-47D3-97A9-266BC7E297E8}" type="slidenum">
              <a:rPr b="0" lang="en-US" sz="8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5"/>
          <p:cNvSpPr/>
          <p:nvPr/>
        </p:nvSpPr>
        <p:spPr>
          <a:xfrm rot="10800000">
            <a:off x="-76320" y="914040"/>
            <a:ext cx="492120" cy="152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8480" rIns="78480" tIns="39240" bIns="39240" anchor="t" vert="eaVert">
            <a:spAutoFit/>
          </a:bodyPr>
          <a:p>
            <a:pPr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Percentage occurrenc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4"/>
          <p:cNvSpPr/>
          <p:nvPr/>
        </p:nvSpPr>
        <p:spPr>
          <a:xfrm>
            <a:off x="1584360" y="3378240"/>
            <a:ext cx="4343400" cy="25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8480" rIns="78480" tIns="39240" bIns="39240" anchor="t">
            <a:spAutoFit/>
          </a:bodyPr>
          <a:p>
            <a:pPr algn="ctr"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Stability of secondary structures in mice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, T=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 37</a:t>
            </a:r>
            <a:r>
              <a:rPr b="0" lang="en-US" sz="1100" spc="-1" strike="noStrike" baseline="50000">
                <a:solidFill>
                  <a:srgbClr val="000000"/>
                </a:solidFill>
                <a:latin typeface="Arial"/>
                <a:ea typeface="Times New Roman"/>
              </a:rPr>
              <a:t>◦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C (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−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kcals/mol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8"/>
          <p:cNvSpPr/>
          <p:nvPr/>
        </p:nvSpPr>
        <p:spPr>
          <a:xfrm>
            <a:off x="201600" y="-19080"/>
            <a:ext cx="25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8480" rIns="78480" tIns="39240" bIns="39240" anchor="t">
            <a:spAutoFit/>
          </a:bodyPr>
          <a:p>
            <a:pPr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9"/>
          <p:cNvSpPr/>
          <p:nvPr/>
        </p:nvSpPr>
        <p:spPr>
          <a:xfrm>
            <a:off x="3630600" y="-19080"/>
            <a:ext cx="25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8480" rIns="78480" tIns="39240" bIns="39240" anchor="t">
            <a:spAutoFit/>
          </a:bodyPr>
          <a:p>
            <a:pPr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8"/>
          <p:cNvSpPr/>
          <p:nvPr/>
        </p:nvSpPr>
        <p:spPr>
          <a:xfrm>
            <a:off x="198000" y="1676520"/>
            <a:ext cx="25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8480" rIns="78480" tIns="39240" bIns="39240" anchor="t">
            <a:spAutoFit/>
          </a:bodyPr>
          <a:p>
            <a:pPr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9"/>
          <p:cNvSpPr/>
          <p:nvPr/>
        </p:nvSpPr>
        <p:spPr>
          <a:xfrm>
            <a:off x="3627000" y="1676520"/>
            <a:ext cx="25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8480" rIns="78480" tIns="39240" bIns="39240" anchor="t">
            <a:spAutoFit/>
          </a:bodyPr>
          <a:p>
            <a:pPr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42"/>
          <p:cNvSpPr/>
          <p:nvPr/>
        </p:nvSpPr>
        <p:spPr>
          <a:xfrm>
            <a:off x="3048120" y="304920"/>
            <a:ext cx="519120" cy="414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91440" bIns="91440" anchor="t">
            <a:spAutoFit/>
          </a:bodyPr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t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ns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43"/>
          <p:cNvSpPr/>
          <p:nvPr/>
        </p:nvSpPr>
        <p:spPr>
          <a:xfrm>
            <a:off x="3084480" y="369720"/>
            <a:ext cx="74520" cy="73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44"/>
          <p:cNvSpPr/>
          <p:nvPr/>
        </p:nvSpPr>
        <p:spPr>
          <a:xfrm>
            <a:off x="3084480" y="527040"/>
            <a:ext cx="74520" cy="73080"/>
          </a:xfrm>
          <a:prstGeom prst="rect">
            <a:avLst/>
          </a:pr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42"/>
          <p:cNvSpPr/>
          <p:nvPr/>
        </p:nvSpPr>
        <p:spPr>
          <a:xfrm>
            <a:off x="3048120" y="2057400"/>
            <a:ext cx="519120" cy="414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91440" bIns="91440" anchor="t">
            <a:spAutoFit/>
          </a:bodyPr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t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ns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43"/>
          <p:cNvSpPr/>
          <p:nvPr/>
        </p:nvSpPr>
        <p:spPr>
          <a:xfrm>
            <a:off x="3084480" y="2122560"/>
            <a:ext cx="74520" cy="73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44"/>
          <p:cNvSpPr/>
          <p:nvPr/>
        </p:nvSpPr>
        <p:spPr>
          <a:xfrm>
            <a:off x="3084480" y="2279520"/>
            <a:ext cx="74520" cy="73080"/>
          </a:xfrm>
          <a:prstGeom prst="rect">
            <a:avLst/>
          </a:pr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42"/>
          <p:cNvSpPr/>
          <p:nvPr/>
        </p:nvSpPr>
        <p:spPr>
          <a:xfrm>
            <a:off x="6553080" y="304920"/>
            <a:ext cx="519120" cy="414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91440" bIns="91440" anchor="t">
            <a:spAutoFit/>
          </a:bodyPr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t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kip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43"/>
          <p:cNvSpPr/>
          <p:nvPr/>
        </p:nvSpPr>
        <p:spPr>
          <a:xfrm>
            <a:off x="6589800" y="369720"/>
            <a:ext cx="74520" cy="73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44"/>
          <p:cNvSpPr/>
          <p:nvPr/>
        </p:nvSpPr>
        <p:spPr>
          <a:xfrm>
            <a:off x="6589800" y="527040"/>
            <a:ext cx="74520" cy="73080"/>
          </a:xfrm>
          <a:prstGeom prst="rect">
            <a:avLst/>
          </a:pr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42"/>
          <p:cNvSpPr/>
          <p:nvPr/>
        </p:nvSpPr>
        <p:spPr>
          <a:xfrm>
            <a:off x="6553080" y="2057400"/>
            <a:ext cx="519120" cy="414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91440" bIns="91440" anchor="t">
            <a:spAutoFit/>
          </a:bodyPr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t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kip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43"/>
          <p:cNvSpPr/>
          <p:nvPr/>
        </p:nvSpPr>
        <p:spPr>
          <a:xfrm>
            <a:off x="6589800" y="2122560"/>
            <a:ext cx="74520" cy="73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44"/>
          <p:cNvSpPr/>
          <p:nvPr/>
        </p:nvSpPr>
        <p:spPr>
          <a:xfrm>
            <a:off x="6589800" y="2279520"/>
            <a:ext cx="74520" cy="73080"/>
          </a:xfrm>
          <a:prstGeom prst="rect">
            <a:avLst/>
          </a:pr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Picture 3" descr=""/>
          <p:cNvPicPr/>
          <p:nvPr/>
        </p:nvPicPr>
        <p:blipFill>
          <a:blip r:embed="rId1"/>
          <a:srcRect l="0" t="34400" r="7925" b="23816"/>
          <a:stretch/>
        </p:blipFill>
        <p:spPr>
          <a:xfrm>
            <a:off x="3757680" y="128520"/>
            <a:ext cx="3506760" cy="158760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4" descr=""/>
          <p:cNvPicPr/>
          <p:nvPr/>
        </p:nvPicPr>
        <p:blipFill>
          <a:blip r:embed="rId2"/>
          <a:srcRect l="0" t="34400" r="7925" b="23816"/>
          <a:stretch/>
        </p:blipFill>
        <p:spPr>
          <a:xfrm>
            <a:off x="247680" y="128520"/>
            <a:ext cx="3505320" cy="158760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8" descr=""/>
          <p:cNvPicPr/>
          <p:nvPr/>
        </p:nvPicPr>
        <p:blipFill>
          <a:blip r:embed="rId3"/>
          <a:srcRect l="0" t="34400" r="7925" b="23816"/>
          <a:stretch/>
        </p:blipFill>
        <p:spPr>
          <a:xfrm>
            <a:off x="247680" y="1847880"/>
            <a:ext cx="3505320" cy="158760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9" descr=""/>
          <p:cNvPicPr/>
          <p:nvPr/>
        </p:nvPicPr>
        <p:blipFill>
          <a:blip r:embed="rId4"/>
          <a:srcRect l="0" t="34400" r="7925" b="23816"/>
          <a:stretch/>
        </p:blipFill>
        <p:spPr>
          <a:xfrm>
            <a:off x="3757680" y="1847880"/>
            <a:ext cx="3506760" cy="1587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liangchen</dc:creator>
  <dc:description/>
  <dc:language>en-US</dc:language>
  <cp:lastModifiedBy>USC College of Letters, Arts &amp; Sciences</cp:lastModifiedBy>
  <dcterms:modified xsi:type="dcterms:W3CDTF">2011-01-26T05:06:58Z</dcterms:modified>
  <cp:revision>35</cp:revision>
  <dc:subject/>
  <dc:title>Slide 1</dc:title>
</cp:coreProperties>
</file>